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12192000" cy="88693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70" userDrawn="1">
          <p15:clr>
            <a:srgbClr val="A4A3A4"/>
          </p15:clr>
        </p15:guide>
        <p15:guide id="2" pos="386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ezahegn G Tessema" initials="GGT" lastIdx="16" clrIdx="0"/>
  <p:cmAuthor id="2" name="Gezahegn G Tessema" initials="GGT [2]" lastIdx="1" clrIdx="1"/>
  <p:cmAuthor id="3" name="Gezahegn G Tessema" initials="GGT [3]" lastIdx="1" clrIdx="2"/>
  <p:cmAuthor id="4" name="Gezahegn G Tessema" initials="GGT [4]" lastIdx="1" clrIdx="3"/>
  <p:cmAuthor id="5" name="Gezahegn G Tessema" initials="GGT [5]" lastIdx="1" clrIdx="4"/>
  <p:cmAuthor id="6" name="Gezahegn G Tessema" initials="GGT [6]" lastIdx="1" clrIdx="5"/>
  <p:cmAuthor id="7" name="Gezahegn G Tessema" initials="GGT [7]" lastIdx="1" clrIdx="6"/>
  <p:cmAuthor id="8" name="Gezahegn G Tessema" initials="GGT [8]" lastIdx="1" clrIdx="7"/>
  <p:cmAuthor id="9" name="Gezahegn G Tessema" initials="GGT [9]" lastIdx="1" clrIdx="8"/>
  <p:cmAuthor id="10" name="Gezahegn G Tessema" initials="GGT [10]" lastIdx="1" clrIdx="9"/>
  <p:cmAuthor id="11" name="Gezahegn G Tessema" initials="GGT [11]" lastIdx="1" clrIdx="10"/>
  <p:cmAuthor id="12" name="Gezahegn G Tessema" initials="GGT [12]" lastIdx="1" clrIdx="11"/>
  <p:cmAuthor id="13" name="Gezahegn G Tessema" initials="GGT [13]" lastIdx="1" clrIdx="1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5B9BD5"/>
    <a:srgbClr val="41719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67" autoAdjust="0"/>
    <p:restoredTop sz="92556"/>
  </p:normalViewPr>
  <p:slideViewPr>
    <p:cSldViewPr snapToGrid="0" showGuides="1">
      <p:cViewPr varScale="1">
        <p:scale>
          <a:sx n="88" d="100"/>
          <a:sy n="88" d="100"/>
        </p:scale>
        <p:origin x="1360" y="192"/>
      </p:cViewPr>
      <p:guideLst>
        <p:guide orient="horz" pos="2770"/>
        <p:guide pos="38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2" d="100"/>
        <a:sy n="10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F5770E-0D53-4D7A-BBAD-E3119384619A}" type="datetimeFigureOut">
              <a:rPr lang="en-US" smtClean="0"/>
              <a:t>6/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08100" y="1143000"/>
            <a:ext cx="4241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BB1A60-AC55-4DDE-AFA7-A8A4D81C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633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51538"/>
            <a:ext cx="10363200" cy="3087852"/>
          </a:xfrm>
        </p:spPr>
        <p:txBody>
          <a:bodyPr anchor="b"/>
          <a:lstStyle>
            <a:lvl1pPr algn="ctr">
              <a:defRPr sz="7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658469"/>
            <a:ext cx="9144000" cy="2141376"/>
          </a:xfrm>
        </p:spPr>
        <p:txBody>
          <a:bodyPr/>
          <a:lstStyle>
            <a:lvl1pPr marL="0" indent="0" algn="ctr">
              <a:buNone/>
              <a:defRPr sz="3104"/>
            </a:lvl1pPr>
            <a:lvl2pPr marL="591297" indent="0" algn="ctr">
              <a:buNone/>
              <a:defRPr sz="2587"/>
            </a:lvl2pPr>
            <a:lvl3pPr marL="1182594" indent="0" algn="ctr">
              <a:buNone/>
              <a:defRPr sz="2328"/>
            </a:lvl3pPr>
            <a:lvl4pPr marL="1773890" indent="0" algn="ctr">
              <a:buNone/>
              <a:defRPr sz="2069"/>
            </a:lvl4pPr>
            <a:lvl5pPr marL="2365187" indent="0" algn="ctr">
              <a:buNone/>
              <a:defRPr sz="2069"/>
            </a:lvl5pPr>
            <a:lvl6pPr marL="2956484" indent="0" algn="ctr">
              <a:buNone/>
              <a:defRPr sz="2069"/>
            </a:lvl6pPr>
            <a:lvl7pPr marL="3547781" indent="0" algn="ctr">
              <a:buNone/>
              <a:defRPr sz="2069"/>
            </a:lvl7pPr>
            <a:lvl8pPr marL="4139077" indent="0" algn="ctr">
              <a:buNone/>
              <a:defRPr sz="2069"/>
            </a:lvl8pPr>
            <a:lvl9pPr marL="4730374" indent="0" algn="ctr">
              <a:buNone/>
              <a:defRPr sz="206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2212"/>
            <a:ext cx="2628900" cy="75163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2212"/>
            <a:ext cx="7734300" cy="75163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11184"/>
            <a:ext cx="10515600" cy="3689408"/>
          </a:xfrm>
        </p:spPr>
        <p:txBody>
          <a:bodyPr anchor="b"/>
          <a:lstStyle>
            <a:lvl1pPr>
              <a:defRPr sz="7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935495"/>
            <a:ext cx="10515600" cy="1940173"/>
          </a:xfrm>
        </p:spPr>
        <p:txBody>
          <a:bodyPr/>
          <a:lstStyle>
            <a:lvl1pPr marL="0" indent="0">
              <a:buNone/>
              <a:defRPr sz="3104">
                <a:solidFill>
                  <a:schemeClr val="tx1"/>
                </a:solidFill>
              </a:defRPr>
            </a:lvl1pPr>
            <a:lvl2pPr marL="591297" indent="0">
              <a:buNone/>
              <a:defRPr sz="2587">
                <a:solidFill>
                  <a:schemeClr val="tx1">
                    <a:tint val="75000"/>
                  </a:schemeClr>
                </a:solidFill>
              </a:defRPr>
            </a:lvl2pPr>
            <a:lvl3pPr marL="1182594" indent="0">
              <a:buNone/>
              <a:defRPr sz="2328">
                <a:solidFill>
                  <a:schemeClr val="tx1">
                    <a:tint val="75000"/>
                  </a:schemeClr>
                </a:solidFill>
              </a:defRPr>
            </a:lvl3pPr>
            <a:lvl4pPr marL="1773890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4pPr>
            <a:lvl5pPr marL="2365187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5pPr>
            <a:lvl6pPr marL="2956484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6pPr>
            <a:lvl7pPr marL="3547781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7pPr>
            <a:lvl8pPr marL="4139077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8pPr>
            <a:lvl9pPr marL="4730374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61057"/>
            <a:ext cx="5181600" cy="562752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61057"/>
            <a:ext cx="5181600" cy="562752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2213"/>
            <a:ext cx="10515600" cy="17143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174226"/>
            <a:ext cx="5157787" cy="1065555"/>
          </a:xfrm>
        </p:spPr>
        <p:txBody>
          <a:bodyPr anchor="b"/>
          <a:lstStyle>
            <a:lvl1pPr marL="0" indent="0">
              <a:buNone/>
              <a:defRPr sz="3104" b="1"/>
            </a:lvl1pPr>
            <a:lvl2pPr marL="591297" indent="0">
              <a:buNone/>
              <a:defRPr sz="2587" b="1"/>
            </a:lvl2pPr>
            <a:lvl3pPr marL="1182594" indent="0">
              <a:buNone/>
              <a:defRPr sz="2328" b="1"/>
            </a:lvl3pPr>
            <a:lvl4pPr marL="1773890" indent="0">
              <a:buNone/>
              <a:defRPr sz="2069" b="1"/>
            </a:lvl4pPr>
            <a:lvl5pPr marL="2365187" indent="0">
              <a:buNone/>
              <a:defRPr sz="2069" b="1"/>
            </a:lvl5pPr>
            <a:lvl6pPr marL="2956484" indent="0">
              <a:buNone/>
              <a:defRPr sz="2069" b="1"/>
            </a:lvl6pPr>
            <a:lvl7pPr marL="3547781" indent="0">
              <a:buNone/>
              <a:defRPr sz="2069" b="1"/>
            </a:lvl7pPr>
            <a:lvl8pPr marL="4139077" indent="0">
              <a:buNone/>
              <a:defRPr sz="2069" b="1"/>
            </a:lvl8pPr>
            <a:lvl9pPr marL="4730374" indent="0">
              <a:buNone/>
              <a:defRPr sz="206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39781"/>
            <a:ext cx="5157787" cy="4765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174226"/>
            <a:ext cx="5183188" cy="1065555"/>
          </a:xfrm>
        </p:spPr>
        <p:txBody>
          <a:bodyPr anchor="b"/>
          <a:lstStyle>
            <a:lvl1pPr marL="0" indent="0">
              <a:buNone/>
              <a:defRPr sz="3104" b="1"/>
            </a:lvl1pPr>
            <a:lvl2pPr marL="591297" indent="0">
              <a:buNone/>
              <a:defRPr sz="2587" b="1"/>
            </a:lvl2pPr>
            <a:lvl3pPr marL="1182594" indent="0">
              <a:buNone/>
              <a:defRPr sz="2328" b="1"/>
            </a:lvl3pPr>
            <a:lvl4pPr marL="1773890" indent="0">
              <a:buNone/>
              <a:defRPr sz="2069" b="1"/>
            </a:lvl4pPr>
            <a:lvl5pPr marL="2365187" indent="0">
              <a:buNone/>
              <a:defRPr sz="2069" b="1"/>
            </a:lvl5pPr>
            <a:lvl6pPr marL="2956484" indent="0">
              <a:buNone/>
              <a:defRPr sz="2069" b="1"/>
            </a:lvl6pPr>
            <a:lvl7pPr marL="3547781" indent="0">
              <a:buNone/>
              <a:defRPr sz="2069" b="1"/>
            </a:lvl7pPr>
            <a:lvl8pPr marL="4139077" indent="0">
              <a:buNone/>
              <a:defRPr sz="2069" b="1"/>
            </a:lvl8pPr>
            <a:lvl9pPr marL="4730374" indent="0">
              <a:buNone/>
              <a:defRPr sz="206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39781"/>
            <a:ext cx="5183188" cy="4765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1291"/>
            <a:ext cx="3932237" cy="2069518"/>
          </a:xfrm>
        </p:spPr>
        <p:txBody>
          <a:bodyPr anchor="b"/>
          <a:lstStyle>
            <a:lvl1pPr>
              <a:defRPr sz="41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77026"/>
            <a:ext cx="6172200" cy="6302996"/>
          </a:xfrm>
        </p:spPr>
        <p:txBody>
          <a:bodyPr/>
          <a:lstStyle>
            <a:lvl1pPr>
              <a:defRPr sz="4139"/>
            </a:lvl1pPr>
            <a:lvl2pPr>
              <a:defRPr sz="3621"/>
            </a:lvl2pPr>
            <a:lvl3pPr>
              <a:defRPr sz="3104"/>
            </a:lvl3pPr>
            <a:lvl4pPr>
              <a:defRPr sz="2587"/>
            </a:lvl4pPr>
            <a:lvl5pPr>
              <a:defRPr sz="2587"/>
            </a:lvl5pPr>
            <a:lvl6pPr>
              <a:defRPr sz="2587"/>
            </a:lvl6pPr>
            <a:lvl7pPr>
              <a:defRPr sz="2587"/>
            </a:lvl7pPr>
            <a:lvl8pPr>
              <a:defRPr sz="2587"/>
            </a:lvl8pPr>
            <a:lvl9pPr>
              <a:defRPr sz="258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60809"/>
            <a:ext cx="3932237" cy="4929478"/>
          </a:xfrm>
        </p:spPr>
        <p:txBody>
          <a:bodyPr/>
          <a:lstStyle>
            <a:lvl1pPr marL="0" indent="0">
              <a:buNone/>
              <a:defRPr sz="2069"/>
            </a:lvl1pPr>
            <a:lvl2pPr marL="591297" indent="0">
              <a:buNone/>
              <a:defRPr sz="1811"/>
            </a:lvl2pPr>
            <a:lvl3pPr marL="1182594" indent="0">
              <a:buNone/>
              <a:defRPr sz="1552"/>
            </a:lvl3pPr>
            <a:lvl4pPr marL="1773890" indent="0">
              <a:buNone/>
              <a:defRPr sz="1293"/>
            </a:lvl4pPr>
            <a:lvl5pPr marL="2365187" indent="0">
              <a:buNone/>
              <a:defRPr sz="1293"/>
            </a:lvl5pPr>
            <a:lvl6pPr marL="2956484" indent="0">
              <a:buNone/>
              <a:defRPr sz="1293"/>
            </a:lvl6pPr>
            <a:lvl7pPr marL="3547781" indent="0">
              <a:buNone/>
              <a:defRPr sz="1293"/>
            </a:lvl7pPr>
            <a:lvl8pPr marL="4139077" indent="0">
              <a:buNone/>
              <a:defRPr sz="1293"/>
            </a:lvl8pPr>
            <a:lvl9pPr marL="4730374" indent="0">
              <a:buNone/>
              <a:defRPr sz="12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1291"/>
            <a:ext cx="3932237" cy="2069518"/>
          </a:xfrm>
        </p:spPr>
        <p:txBody>
          <a:bodyPr anchor="b"/>
          <a:lstStyle>
            <a:lvl1pPr>
              <a:defRPr sz="41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77026"/>
            <a:ext cx="6172200" cy="6302996"/>
          </a:xfrm>
        </p:spPr>
        <p:txBody>
          <a:bodyPr anchor="t"/>
          <a:lstStyle>
            <a:lvl1pPr marL="0" indent="0">
              <a:buNone/>
              <a:defRPr sz="4139"/>
            </a:lvl1pPr>
            <a:lvl2pPr marL="591297" indent="0">
              <a:buNone/>
              <a:defRPr sz="3621"/>
            </a:lvl2pPr>
            <a:lvl3pPr marL="1182594" indent="0">
              <a:buNone/>
              <a:defRPr sz="3104"/>
            </a:lvl3pPr>
            <a:lvl4pPr marL="1773890" indent="0">
              <a:buNone/>
              <a:defRPr sz="2587"/>
            </a:lvl4pPr>
            <a:lvl5pPr marL="2365187" indent="0">
              <a:buNone/>
              <a:defRPr sz="2587"/>
            </a:lvl5pPr>
            <a:lvl6pPr marL="2956484" indent="0">
              <a:buNone/>
              <a:defRPr sz="2587"/>
            </a:lvl6pPr>
            <a:lvl7pPr marL="3547781" indent="0">
              <a:buNone/>
              <a:defRPr sz="2587"/>
            </a:lvl7pPr>
            <a:lvl8pPr marL="4139077" indent="0">
              <a:buNone/>
              <a:defRPr sz="2587"/>
            </a:lvl8pPr>
            <a:lvl9pPr marL="4730374" indent="0">
              <a:buNone/>
              <a:defRPr sz="2587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60809"/>
            <a:ext cx="3932237" cy="4929478"/>
          </a:xfrm>
        </p:spPr>
        <p:txBody>
          <a:bodyPr/>
          <a:lstStyle>
            <a:lvl1pPr marL="0" indent="0">
              <a:buNone/>
              <a:defRPr sz="2069"/>
            </a:lvl1pPr>
            <a:lvl2pPr marL="591297" indent="0">
              <a:buNone/>
              <a:defRPr sz="1811"/>
            </a:lvl2pPr>
            <a:lvl3pPr marL="1182594" indent="0">
              <a:buNone/>
              <a:defRPr sz="1552"/>
            </a:lvl3pPr>
            <a:lvl4pPr marL="1773890" indent="0">
              <a:buNone/>
              <a:defRPr sz="1293"/>
            </a:lvl4pPr>
            <a:lvl5pPr marL="2365187" indent="0">
              <a:buNone/>
              <a:defRPr sz="1293"/>
            </a:lvl5pPr>
            <a:lvl6pPr marL="2956484" indent="0">
              <a:buNone/>
              <a:defRPr sz="1293"/>
            </a:lvl6pPr>
            <a:lvl7pPr marL="3547781" indent="0">
              <a:buNone/>
              <a:defRPr sz="1293"/>
            </a:lvl7pPr>
            <a:lvl8pPr marL="4139077" indent="0">
              <a:buNone/>
              <a:defRPr sz="1293"/>
            </a:lvl8pPr>
            <a:lvl9pPr marL="4730374" indent="0">
              <a:buNone/>
              <a:defRPr sz="12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2213"/>
            <a:ext cx="10515600" cy="17143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61057"/>
            <a:ext cx="10515600" cy="56275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220588"/>
            <a:ext cx="2743200" cy="4722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B680E-DBBD-47DE-A4E3-3A24245DCCF2}" type="datetimeFigureOut">
              <a:rPr lang="en-US" smtClean="0"/>
              <a:t>6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220588"/>
            <a:ext cx="4114800" cy="4722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220588"/>
            <a:ext cx="2743200" cy="4722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EC38C-85CE-4DC0-8CF8-1A2FA38FA0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264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82594" rtl="0" eaLnBrk="1" latinLnBrk="0" hangingPunct="1">
        <a:lnSpc>
          <a:spcPct val="90000"/>
        </a:lnSpc>
        <a:spcBef>
          <a:spcPct val="0"/>
        </a:spcBef>
        <a:buNone/>
        <a:defRPr sz="569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5648" indent="-295648" algn="l" defTabSz="1182594" rtl="0" eaLnBrk="1" latinLnBrk="0" hangingPunct="1">
        <a:lnSpc>
          <a:spcPct val="90000"/>
        </a:lnSpc>
        <a:spcBef>
          <a:spcPts val="1293"/>
        </a:spcBef>
        <a:buFont typeface="Arial" panose="020B0604020202020204" pitchFamily="34" charset="0"/>
        <a:buChar char="•"/>
        <a:defRPr sz="3621" kern="1200">
          <a:solidFill>
            <a:schemeClr val="tx1"/>
          </a:solidFill>
          <a:latin typeface="+mn-lt"/>
          <a:ea typeface="+mn-ea"/>
          <a:cs typeface="+mn-cs"/>
        </a:defRPr>
      </a:lvl1pPr>
      <a:lvl2pPr marL="886945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3104" kern="1200">
          <a:solidFill>
            <a:schemeClr val="tx1"/>
          </a:solidFill>
          <a:latin typeface="+mn-lt"/>
          <a:ea typeface="+mn-ea"/>
          <a:cs typeface="+mn-cs"/>
        </a:defRPr>
      </a:lvl2pPr>
      <a:lvl3pPr marL="1478242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587" kern="1200">
          <a:solidFill>
            <a:schemeClr val="tx1"/>
          </a:solidFill>
          <a:latin typeface="+mn-lt"/>
          <a:ea typeface="+mn-ea"/>
          <a:cs typeface="+mn-cs"/>
        </a:defRPr>
      </a:lvl3pPr>
      <a:lvl4pPr marL="2069539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4pPr>
      <a:lvl5pPr marL="2660835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5pPr>
      <a:lvl6pPr marL="3252132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6pPr>
      <a:lvl7pPr marL="3843429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7pPr>
      <a:lvl8pPr marL="4434726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8pPr>
      <a:lvl9pPr marL="5026022" indent="-295648" algn="l" defTabSz="1182594" rtl="0" eaLnBrk="1" latinLnBrk="0" hangingPunct="1">
        <a:lnSpc>
          <a:spcPct val="90000"/>
        </a:lnSpc>
        <a:spcBef>
          <a:spcPts val="647"/>
        </a:spcBef>
        <a:buFont typeface="Arial" panose="020B0604020202020204" pitchFamily="34" charset="0"/>
        <a:buChar char="•"/>
        <a:defRPr sz="23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1pPr>
      <a:lvl2pPr marL="591297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2pPr>
      <a:lvl3pPr marL="1182594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3pPr>
      <a:lvl4pPr marL="1773890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4pPr>
      <a:lvl5pPr marL="2365187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5pPr>
      <a:lvl6pPr marL="2956484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6pPr>
      <a:lvl7pPr marL="3547781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7pPr>
      <a:lvl8pPr marL="4139077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8pPr>
      <a:lvl9pPr marL="4730374" algn="l" defTabSz="1182594" rtl="0" eaLnBrk="1" latinLnBrk="0" hangingPunct="1">
        <a:defRPr sz="23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758218" y="1303544"/>
            <a:ext cx="10372582" cy="5052037"/>
            <a:chOff x="456654" y="1519709"/>
            <a:chExt cx="10372582" cy="5052037"/>
          </a:xfrm>
        </p:grpSpPr>
        <p:grpSp>
          <p:nvGrpSpPr>
            <p:cNvPr id="34" name="Group 33"/>
            <p:cNvGrpSpPr/>
            <p:nvPr/>
          </p:nvGrpSpPr>
          <p:grpSpPr>
            <a:xfrm>
              <a:off x="456654" y="1916004"/>
              <a:ext cx="3085919" cy="4655742"/>
              <a:chOff x="362137" y="957477"/>
              <a:chExt cx="3004246" cy="4562109"/>
            </a:xfrm>
          </p:grpSpPr>
          <p:grpSp>
            <p:nvGrpSpPr>
              <p:cNvPr id="28" name="Group 27"/>
              <p:cNvGrpSpPr/>
              <p:nvPr/>
            </p:nvGrpSpPr>
            <p:grpSpPr>
              <a:xfrm>
                <a:off x="362137" y="3152500"/>
                <a:ext cx="3003972" cy="2367086"/>
                <a:chOff x="362137" y="2885391"/>
                <a:chExt cx="3003972" cy="2367086"/>
              </a:xfrm>
            </p:grpSpPr>
            <p:sp>
              <p:nvSpPr>
                <p:cNvPr id="13" name="Rectangle 12"/>
                <p:cNvSpPr/>
                <p:nvPr/>
              </p:nvSpPr>
              <p:spPr>
                <a:xfrm>
                  <a:off x="362137" y="2885391"/>
                  <a:ext cx="2926080" cy="38796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sz="1600" dirty="0"/>
                    <a:t>Select size between 18 </a:t>
                  </a:r>
                  <a:r>
                    <a:rPr lang="en-US" sz="1600" dirty="0" err="1"/>
                    <a:t>nt</a:t>
                  </a:r>
                  <a:r>
                    <a:rPr lang="en-US" sz="1600" dirty="0"/>
                    <a:t> and 28nt</a:t>
                  </a:r>
                </a:p>
              </p:txBody>
            </p:sp>
            <p:sp>
              <p:nvSpPr>
                <p:cNvPr id="15" name="Down Arrow 14"/>
                <p:cNvSpPr/>
                <p:nvPr/>
              </p:nvSpPr>
              <p:spPr>
                <a:xfrm>
                  <a:off x="1737360" y="3950174"/>
                  <a:ext cx="297180" cy="36576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2034540" y="3982347"/>
                  <a:ext cx="1010810" cy="28575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dirty="0"/>
                    <a:t>Step 5</a:t>
                  </a:r>
                </a:p>
              </p:txBody>
            </p:sp>
            <p:sp>
              <p:nvSpPr>
                <p:cNvPr id="24" name="Rectangle 23"/>
                <p:cNvSpPr/>
                <p:nvPr/>
              </p:nvSpPr>
              <p:spPr>
                <a:xfrm>
                  <a:off x="362137" y="4991751"/>
                  <a:ext cx="1485383" cy="253095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sz="1600" dirty="0"/>
                    <a:t>known miRNAs</a:t>
                  </a: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1920462" y="4976670"/>
                  <a:ext cx="1445647" cy="27580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sz="1600" dirty="0"/>
                    <a:t>Novel miRNAs</a:t>
                  </a:r>
                </a:p>
              </p:txBody>
            </p:sp>
          </p:grpSp>
          <p:grpSp>
            <p:nvGrpSpPr>
              <p:cNvPr id="33" name="Group 32"/>
              <p:cNvGrpSpPr/>
              <p:nvPr/>
            </p:nvGrpSpPr>
            <p:grpSpPr>
              <a:xfrm>
                <a:off x="362137" y="957477"/>
                <a:ext cx="3004246" cy="3252093"/>
                <a:chOff x="362137" y="957477"/>
                <a:chExt cx="3004246" cy="3252093"/>
              </a:xfrm>
            </p:grpSpPr>
            <p:grpSp>
              <p:nvGrpSpPr>
                <p:cNvPr id="29" name="Group 28"/>
                <p:cNvGrpSpPr/>
                <p:nvPr/>
              </p:nvGrpSpPr>
              <p:grpSpPr>
                <a:xfrm>
                  <a:off x="362137" y="957477"/>
                  <a:ext cx="2986853" cy="2180920"/>
                  <a:chOff x="362137" y="1076744"/>
                  <a:chExt cx="2986853" cy="2180920"/>
                </a:xfrm>
              </p:grpSpPr>
              <p:sp>
                <p:nvSpPr>
                  <p:cNvPr id="3" name="Rectangle 2"/>
                  <p:cNvSpPr/>
                  <p:nvPr/>
                </p:nvSpPr>
                <p:spPr>
                  <a:xfrm>
                    <a:off x="362137" y="1076744"/>
                    <a:ext cx="2986853" cy="327655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600" dirty="0"/>
                      <a:t>Small </a:t>
                    </a:r>
                    <a:r>
                      <a:rPr lang="en-US" sz="1600"/>
                      <a:t>RNA sequencing </a:t>
                    </a:r>
                    <a:r>
                      <a:rPr lang="en-US" sz="1600" dirty="0"/>
                      <a:t>reads</a:t>
                    </a:r>
                  </a:p>
                </p:txBody>
              </p:sp>
              <p:sp>
                <p:nvSpPr>
                  <p:cNvPr id="4" name="Down Arrow 3"/>
                  <p:cNvSpPr/>
                  <p:nvPr/>
                </p:nvSpPr>
                <p:spPr>
                  <a:xfrm>
                    <a:off x="1737360" y="1417320"/>
                    <a:ext cx="297180" cy="365760"/>
                  </a:xfrm>
                  <a:prstGeom prst="down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  <p:sp>
                <p:nvSpPr>
                  <p:cNvPr id="6" name="Rectangle 5"/>
                  <p:cNvSpPr/>
                  <p:nvPr/>
                </p:nvSpPr>
                <p:spPr>
                  <a:xfrm>
                    <a:off x="362137" y="1744976"/>
                    <a:ext cx="2986853" cy="44163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>
                      <a:lnSpc>
                        <a:spcPts val="1200"/>
                      </a:lnSpc>
                    </a:pPr>
                    <a:r>
                      <a:rPr lang="en-US" sz="1600" dirty="0"/>
                      <a:t>Remove adaptor and low quality reads</a:t>
                    </a:r>
                  </a:p>
                </p:txBody>
              </p:sp>
              <p:sp>
                <p:nvSpPr>
                  <p:cNvPr id="7" name="Rectangle 6"/>
                  <p:cNvSpPr/>
                  <p:nvPr/>
                </p:nvSpPr>
                <p:spPr>
                  <a:xfrm>
                    <a:off x="2058393" y="1463040"/>
                    <a:ext cx="1010810" cy="285750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600" dirty="0"/>
                      <a:t>Step 1</a:t>
                    </a:r>
                  </a:p>
                </p:txBody>
              </p:sp>
              <p:sp>
                <p:nvSpPr>
                  <p:cNvPr id="9" name="Down Arrow 8"/>
                  <p:cNvSpPr/>
                  <p:nvPr/>
                </p:nvSpPr>
                <p:spPr>
                  <a:xfrm>
                    <a:off x="1737360" y="2205498"/>
                    <a:ext cx="297180" cy="365760"/>
                  </a:xfrm>
                  <a:prstGeom prst="down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  <p:sp>
                <p:nvSpPr>
                  <p:cNvPr id="10" name="Rectangle 9"/>
                  <p:cNvSpPr/>
                  <p:nvPr/>
                </p:nvSpPr>
                <p:spPr>
                  <a:xfrm>
                    <a:off x="362137" y="2592387"/>
                    <a:ext cx="2986853" cy="277289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>
                      <a:lnSpc>
                        <a:spcPts val="1200"/>
                      </a:lnSpc>
                    </a:pPr>
                    <a:r>
                      <a:rPr lang="en-US" sz="1600" dirty="0"/>
                      <a:t>Remove </a:t>
                    </a:r>
                    <a:r>
                      <a:rPr lang="en-US" sz="1600" dirty="0" err="1"/>
                      <a:t>tRNAs</a:t>
                    </a:r>
                    <a:r>
                      <a:rPr lang="en-US" sz="1600" dirty="0"/>
                      <a:t> and </a:t>
                    </a:r>
                    <a:r>
                      <a:rPr lang="en-US" sz="1600" dirty="0" err="1"/>
                      <a:t>rRNAs</a:t>
                    </a:r>
                    <a:endParaRPr lang="en-US" sz="1600" dirty="0"/>
                  </a:p>
                </p:txBody>
              </p:sp>
              <p:sp>
                <p:nvSpPr>
                  <p:cNvPr id="11" name="Rectangle 10"/>
                  <p:cNvSpPr/>
                  <p:nvPr/>
                </p:nvSpPr>
                <p:spPr>
                  <a:xfrm>
                    <a:off x="2058393" y="2253207"/>
                    <a:ext cx="1010810" cy="285750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600" dirty="0"/>
                      <a:t>Step 2</a:t>
                    </a:r>
                  </a:p>
                </p:txBody>
              </p:sp>
              <p:sp>
                <p:nvSpPr>
                  <p:cNvPr id="12" name="Down Arrow 11"/>
                  <p:cNvSpPr/>
                  <p:nvPr/>
                </p:nvSpPr>
                <p:spPr>
                  <a:xfrm>
                    <a:off x="1737360" y="2891904"/>
                    <a:ext cx="297180" cy="365760"/>
                  </a:xfrm>
                  <a:prstGeom prst="down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  <p:sp>
                <p:nvSpPr>
                  <p:cNvPr id="14" name="Rectangle 13"/>
                  <p:cNvSpPr/>
                  <p:nvPr/>
                </p:nvSpPr>
                <p:spPr>
                  <a:xfrm>
                    <a:off x="2058393" y="2915640"/>
                    <a:ext cx="1010810" cy="285750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600" dirty="0"/>
                      <a:t>Step 3</a:t>
                    </a:r>
                  </a:p>
                </p:txBody>
              </p:sp>
            </p:grpSp>
            <p:sp>
              <p:nvSpPr>
                <p:cNvPr id="30" name="Rectangle 29"/>
                <p:cNvSpPr/>
                <p:nvPr/>
              </p:nvSpPr>
              <p:spPr>
                <a:xfrm>
                  <a:off x="362137" y="3947727"/>
                  <a:ext cx="3004246" cy="261843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ts val="1200"/>
                    </a:lnSpc>
                  </a:pPr>
                  <a:r>
                    <a:rPr lang="en-US" sz="1600" dirty="0" err="1"/>
                    <a:t>reomve</a:t>
                  </a:r>
                  <a:r>
                    <a:rPr lang="en-US" sz="1600" dirty="0"/>
                    <a:t> Cs genome read TPM &lt;10</a:t>
                  </a:r>
                </a:p>
              </p:txBody>
            </p:sp>
            <p:sp>
              <p:nvSpPr>
                <p:cNvPr id="31" name="Down Arrow 30"/>
                <p:cNvSpPr/>
                <p:nvPr/>
              </p:nvSpPr>
              <p:spPr>
                <a:xfrm>
                  <a:off x="1754753" y="3556427"/>
                  <a:ext cx="297180" cy="36576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32" name="Rectangle 31"/>
                <p:cNvSpPr/>
                <p:nvPr/>
              </p:nvSpPr>
              <p:spPr>
                <a:xfrm>
                  <a:off x="2058393" y="3593898"/>
                  <a:ext cx="1010810" cy="28575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dirty="0"/>
                    <a:t>Step 4</a:t>
                  </a:r>
                </a:p>
              </p:txBody>
            </p:sp>
          </p:grpSp>
        </p:grpSp>
        <p:grpSp>
          <p:nvGrpSpPr>
            <p:cNvPr id="8" name="Group 7"/>
            <p:cNvGrpSpPr/>
            <p:nvPr/>
          </p:nvGrpSpPr>
          <p:grpSpPr>
            <a:xfrm>
              <a:off x="3606906" y="1519709"/>
              <a:ext cx="7222330" cy="4362748"/>
              <a:chOff x="3248195" y="505478"/>
              <a:chExt cx="7222330" cy="4299281"/>
            </a:xfrm>
          </p:grpSpPr>
          <p:grpSp>
            <p:nvGrpSpPr>
              <p:cNvPr id="91" name="Group 90"/>
              <p:cNvGrpSpPr/>
              <p:nvPr/>
            </p:nvGrpSpPr>
            <p:grpSpPr>
              <a:xfrm>
                <a:off x="3248195" y="505478"/>
                <a:ext cx="7222330" cy="3649736"/>
                <a:chOff x="3508756" y="508825"/>
                <a:chExt cx="7222330" cy="3649736"/>
              </a:xfrm>
            </p:grpSpPr>
            <p:grpSp>
              <p:nvGrpSpPr>
                <p:cNvPr id="40" name="Group 39"/>
                <p:cNvGrpSpPr/>
                <p:nvPr/>
              </p:nvGrpSpPr>
              <p:grpSpPr>
                <a:xfrm>
                  <a:off x="3508756" y="508825"/>
                  <a:ext cx="7222330" cy="274320"/>
                  <a:chOff x="4579566" y="414314"/>
                  <a:chExt cx="7222330" cy="433206"/>
                </a:xfrm>
              </p:grpSpPr>
              <p:sp>
                <p:nvSpPr>
                  <p:cNvPr id="35" name="Rectangle 34"/>
                  <p:cNvSpPr/>
                  <p:nvPr/>
                </p:nvSpPr>
                <p:spPr>
                  <a:xfrm>
                    <a:off x="4579566" y="435917"/>
                    <a:ext cx="1661862" cy="411603"/>
                  </a:xfrm>
                  <a:prstGeom prst="rect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SC283_mock</a:t>
                    </a:r>
                  </a:p>
                </p:txBody>
              </p:sp>
              <p:sp>
                <p:nvSpPr>
                  <p:cNvPr id="36" name="Rectangle 35"/>
                  <p:cNvSpPr/>
                  <p:nvPr/>
                </p:nvSpPr>
                <p:spPr>
                  <a:xfrm>
                    <a:off x="6393889" y="414314"/>
                    <a:ext cx="1661862" cy="411603"/>
                  </a:xfrm>
                  <a:prstGeom prst="rect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SC283_48hpi</a:t>
                    </a:r>
                  </a:p>
                </p:txBody>
              </p:sp>
              <p:sp>
                <p:nvSpPr>
                  <p:cNvPr id="37" name="Rectangle 36"/>
                  <p:cNvSpPr/>
                  <p:nvPr/>
                </p:nvSpPr>
                <p:spPr>
                  <a:xfrm>
                    <a:off x="10140034" y="433636"/>
                    <a:ext cx="1661862" cy="411603"/>
                  </a:xfrm>
                  <a:prstGeom prst="rect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TAM428_48hpi</a:t>
                    </a:r>
                  </a:p>
                </p:txBody>
              </p:sp>
              <p:sp>
                <p:nvSpPr>
                  <p:cNvPr id="38" name="Rectangle 37"/>
                  <p:cNvSpPr/>
                  <p:nvPr/>
                </p:nvSpPr>
                <p:spPr>
                  <a:xfrm>
                    <a:off x="8208213" y="435916"/>
                    <a:ext cx="1830681" cy="411602"/>
                  </a:xfrm>
                  <a:prstGeom prst="rect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TAM428_mock</a:t>
                    </a:r>
                  </a:p>
                </p:txBody>
              </p:sp>
            </p:grpSp>
            <p:sp>
              <p:nvSpPr>
                <p:cNvPr id="5" name="Rectangle 4"/>
                <p:cNvSpPr/>
                <p:nvPr/>
              </p:nvSpPr>
              <p:spPr>
                <a:xfrm>
                  <a:off x="3659104" y="985918"/>
                  <a:ext cx="1391151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9,501,590 </a:t>
                  </a:r>
                </a:p>
              </p:txBody>
            </p:sp>
            <p:sp>
              <p:nvSpPr>
                <p:cNvPr id="39" name="Rectangle 38"/>
                <p:cNvSpPr/>
                <p:nvPr/>
              </p:nvSpPr>
              <p:spPr>
                <a:xfrm>
                  <a:off x="5439546" y="954687"/>
                  <a:ext cx="1391151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5,641,164  </a:t>
                  </a:r>
                </a:p>
              </p:txBody>
            </p:sp>
            <p:sp>
              <p:nvSpPr>
                <p:cNvPr id="41" name="Rectangle 40"/>
                <p:cNvSpPr/>
                <p:nvPr/>
              </p:nvSpPr>
              <p:spPr>
                <a:xfrm>
                  <a:off x="3659104" y="974488"/>
                  <a:ext cx="1391151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9,501,590 </a:t>
                  </a:r>
                </a:p>
              </p:txBody>
            </p:sp>
            <p:sp>
              <p:nvSpPr>
                <p:cNvPr id="42" name="Rectangle 41"/>
                <p:cNvSpPr/>
                <p:nvPr/>
              </p:nvSpPr>
              <p:spPr>
                <a:xfrm>
                  <a:off x="7355393" y="985918"/>
                  <a:ext cx="1391151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61,644,788 </a:t>
                  </a:r>
                </a:p>
              </p:txBody>
            </p:sp>
            <p:sp>
              <p:nvSpPr>
                <p:cNvPr id="43" name="Rectangle 42"/>
                <p:cNvSpPr/>
                <p:nvPr/>
              </p:nvSpPr>
              <p:spPr>
                <a:xfrm>
                  <a:off x="9219572" y="954687"/>
                  <a:ext cx="1511512" cy="300658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1,441,395 </a:t>
                  </a:r>
                </a:p>
              </p:txBody>
            </p:sp>
            <p:sp>
              <p:nvSpPr>
                <p:cNvPr id="44" name="Down Arrow 43"/>
                <p:cNvSpPr/>
                <p:nvPr/>
              </p:nvSpPr>
              <p:spPr>
                <a:xfrm>
                  <a:off x="4202049" y="1256077"/>
                  <a:ext cx="305259" cy="27432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45" name="Down Arrow 44"/>
                <p:cNvSpPr/>
                <p:nvPr/>
              </p:nvSpPr>
              <p:spPr>
                <a:xfrm>
                  <a:off x="5949554" y="1250685"/>
                  <a:ext cx="305259" cy="27432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46" name="Down Arrow 45"/>
                <p:cNvSpPr/>
                <p:nvPr/>
              </p:nvSpPr>
              <p:spPr>
                <a:xfrm>
                  <a:off x="7915106" y="1256077"/>
                  <a:ext cx="305259" cy="27432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47" name="Down Arrow 46"/>
                <p:cNvSpPr/>
                <p:nvPr/>
              </p:nvSpPr>
              <p:spPr>
                <a:xfrm>
                  <a:off x="9762517" y="1254106"/>
                  <a:ext cx="305259" cy="27432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grpSp>
              <p:nvGrpSpPr>
                <p:cNvPr id="65" name="Group 64"/>
                <p:cNvGrpSpPr/>
                <p:nvPr/>
              </p:nvGrpSpPr>
              <p:grpSpPr>
                <a:xfrm>
                  <a:off x="3647745" y="1530397"/>
                  <a:ext cx="7083339" cy="296237"/>
                  <a:chOff x="3647745" y="1530397"/>
                  <a:chExt cx="7083339" cy="296237"/>
                </a:xfrm>
              </p:grpSpPr>
              <p:sp>
                <p:nvSpPr>
                  <p:cNvPr id="48" name="Rectangle 47"/>
                  <p:cNvSpPr/>
                  <p:nvPr/>
                </p:nvSpPr>
                <p:spPr>
                  <a:xfrm>
                    <a:off x="3647745" y="1557207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57,236,319  </a:t>
                    </a:r>
                  </a:p>
                </p:txBody>
              </p:sp>
              <p:sp>
                <p:nvSpPr>
                  <p:cNvPr id="49" name="Rectangle 48"/>
                  <p:cNvSpPr/>
                  <p:nvPr/>
                </p:nvSpPr>
                <p:spPr>
                  <a:xfrm>
                    <a:off x="5446894" y="1554761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55,045,967  </a:t>
                    </a:r>
                  </a:p>
                </p:txBody>
              </p:sp>
              <p:sp>
                <p:nvSpPr>
                  <p:cNvPr id="50" name="Rectangle 49"/>
                  <p:cNvSpPr/>
                  <p:nvPr/>
                </p:nvSpPr>
                <p:spPr>
                  <a:xfrm>
                    <a:off x="7351382" y="1555984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59,037,560  </a:t>
                    </a:r>
                  </a:p>
                </p:txBody>
              </p:sp>
              <p:sp>
                <p:nvSpPr>
                  <p:cNvPr id="51" name="Rectangle 50"/>
                  <p:cNvSpPr/>
                  <p:nvPr/>
                </p:nvSpPr>
                <p:spPr>
                  <a:xfrm>
                    <a:off x="9263218" y="1530397"/>
                    <a:ext cx="1467866" cy="286029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50,751,177  </a:t>
                    </a:r>
                  </a:p>
                </p:txBody>
              </p:sp>
            </p:grpSp>
            <p:sp>
              <p:nvSpPr>
                <p:cNvPr id="52" name="Down Arrow 51"/>
                <p:cNvSpPr/>
                <p:nvPr/>
              </p:nvSpPr>
              <p:spPr>
                <a:xfrm>
                  <a:off x="4190690" y="1853583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53" name="Down Arrow 52"/>
                <p:cNvSpPr/>
                <p:nvPr/>
              </p:nvSpPr>
              <p:spPr>
                <a:xfrm>
                  <a:off x="5965265" y="1867647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54" name="Down Arrow 53"/>
                <p:cNvSpPr/>
                <p:nvPr/>
              </p:nvSpPr>
              <p:spPr>
                <a:xfrm>
                  <a:off x="7915105" y="1867647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55" name="Down Arrow 54"/>
                <p:cNvSpPr/>
                <p:nvPr/>
              </p:nvSpPr>
              <p:spPr>
                <a:xfrm>
                  <a:off x="9762516" y="1863665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>
                  <a:off x="3647743" y="2253800"/>
                  <a:ext cx="1391151" cy="401718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2,123,697  </a:t>
                  </a:r>
                </a:p>
              </p:txBody>
            </p:sp>
            <p:sp>
              <p:nvSpPr>
                <p:cNvPr id="58" name="Rectangle 57"/>
                <p:cNvSpPr/>
                <p:nvPr/>
              </p:nvSpPr>
              <p:spPr>
                <a:xfrm>
                  <a:off x="5446893" y="2264386"/>
                  <a:ext cx="1391151" cy="401718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3,122,375   </a:t>
                  </a:r>
                </a:p>
              </p:txBody>
            </p:sp>
            <p:sp>
              <p:nvSpPr>
                <p:cNvPr id="59" name="Rectangle 58"/>
                <p:cNvSpPr/>
                <p:nvPr/>
              </p:nvSpPr>
              <p:spPr>
                <a:xfrm>
                  <a:off x="7351379" y="2264047"/>
                  <a:ext cx="1391151" cy="401718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3122375   </a:t>
                  </a:r>
                </a:p>
              </p:txBody>
            </p:sp>
            <p:sp>
              <p:nvSpPr>
                <p:cNvPr id="60" name="Rectangle 59"/>
                <p:cNvSpPr/>
                <p:nvPr/>
              </p:nvSpPr>
              <p:spPr>
                <a:xfrm>
                  <a:off x="9263218" y="2236931"/>
                  <a:ext cx="1467866" cy="428833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46326248   </a:t>
                  </a:r>
                </a:p>
              </p:txBody>
            </p:sp>
            <p:sp>
              <p:nvSpPr>
                <p:cNvPr id="61" name="Down Arrow 60"/>
                <p:cNvSpPr/>
                <p:nvPr/>
              </p:nvSpPr>
              <p:spPr>
                <a:xfrm>
                  <a:off x="4174979" y="2678005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62" name="Down Arrow 61"/>
                <p:cNvSpPr/>
                <p:nvPr/>
              </p:nvSpPr>
              <p:spPr>
                <a:xfrm>
                  <a:off x="5949554" y="2692069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63" name="Down Arrow 62"/>
                <p:cNvSpPr/>
                <p:nvPr/>
              </p:nvSpPr>
              <p:spPr>
                <a:xfrm>
                  <a:off x="7899394" y="2692069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64" name="Down Arrow 63"/>
                <p:cNvSpPr/>
                <p:nvPr/>
              </p:nvSpPr>
              <p:spPr>
                <a:xfrm>
                  <a:off x="9746805" y="2688087"/>
                  <a:ext cx="305259" cy="373267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grpSp>
              <p:nvGrpSpPr>
                <p:cNvPr id="66" name="Group 65"/>
                <p:cNvGrpSpPr/>
                <p:nvPr/>
              </p:nvGrpSpPr>
              <p:grpSpPr>
                <a:xfrm>
                  <a:off x="3659104" y="3051272"/>
                  <a:ext cx="7071980" cy="289717"/>
                  <a:chOff x="3647745" y="1536917"/>
                  <a:chExt cx="7071980" cy="289717"/>
                </a:xfrm>
              </p:grpSpPr>
              <p:sp>
                <p:nvSpPr>
                  <p:cNvPr id="67" name="Rectangle 66"/>
                  <p:cNvSpPr/>
                  <p:nvPr/>
                </p:nvSpPr>
                <p:spPr>
                  <a:xfrm>
                    <a:off x="3647745" y="1557207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16,215,578    </a:t>
                    </a:r>
                  </a:p>
                </p:txBody>
              </p:sp>
              <p:sp>
                <p:nvSpPr>
                  <p:cNvPr id="68" name="Rectangle 67"/>
                  <p:cNvSpPr/>
                  <p:nvPr/>
                </p:nvSpPr>
                <p:spPr>
                  <a:xfrm>
                    <a:off x="5446894" y="1554761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19,631,820   </a:t>
                    </a:r>
                  </a:p>
                </p:txBody>
              </p:sp>
              <p:sp>
                <p:nvSpPr>
                  <p:cNvPr id="69" name="Rectangle 68"/>
                  <p:cNvSpPr/>
                  <p:nvPr/>
                </p:nvSpPr>
                <p:spPr>
                  <a:xfrm>
                    <a:off x="7351382" y="1555984"/>
                    <a:ext cx="1391151" cy="26942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10,664,694   </a:t>
                    </a:r>
                  </a:p>
                </p:txBody>
              </p:sp>
              <p:sp>
                <p:nvSpPr>
                  <p:cNvPr id="70" name="Rectangle 69"/>
                  <p:cNvSpPr/>
                  <p:nvPr/>
                </p:nvSpPr>
                <p:spPr>
                  <a:xfrm>
                    <a:off x="9263218" y="1536917"/>
                    <a:ext cx="1456507" cy="279507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dirty="0"/>
                      <a:t>7,151,637  </a:t>
                    </a:r>
                  </a:p>
                </p:txBody>
              </p:sp>
            </p:grpSp>
            <p:sp>
              <p:nvSpPr>
                <p:cNvPr id="76" name="Down Arrow 75"/>
                <p:cNvSpPr/>
                <p:nvPr/>
              </p:nvSpPr>
              <p:spPr>
                <a:xfrm>
                  <a:off x="5964698" y="3336015"/>
                  <a:ext cx="305259" cy="54864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77" name="Down Arrow 76"/>
                <p:cNvSpPr/>
                <p:nvPr/>
              </p:nvSpPr>
              <p:spPr>
                <a:xfrm>
                  <a:off x="9762516" y="3329733"/>
                  <a:ext cx="305259" cy="54864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>
                  <a:off x="3760564" y="3889134"/>
                  <a:ext cx="1097280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54,628     </a:t>
                  </a:r>
                </a:p>
              </p:txBody>
            </p:sp>
            <p:sp>
              <p:nvSpPr>
                <p:cNvPr id="80" name="Rectangle 79"/>
                <p:cNvSpPr/>
                <p:nvPr/>
              </p:nvSpPr>
              <p:spPr>
                <a:xfrm>
                  <a:off x="5499814" y="3889134"/>
                  <a:ext cx="1097280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75,251</a:t>
                  </a:r>
                </a:p>
              </p:txBody>
            </p:sp>
            <p:sp>
              <p:nvSpPr>
                <p:cNvPr id="81" name="Rectangle 80"/>
                <p:cNvSpPr/>
                <p:nvPr/>
              </p:nvSpPr>
              <p:spPr>
                <a:xfrm>
                  <a:off x="9410153" y="3862657"/>
                  <a:ext cx="1320932" cy="285415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43,557 </a:t>
                  </a:r>
                </a:p>
              </p:txBody>
            </p:sp>
            <p:sp>
              <p:nvSpPr>
                <p:cNvPr id="82" name="Rectangle 81"/>
                <p:cNvSpPr/>
                <p:nvPr/>
              </p:nvSpPr>
              <p:spPr>
                <a:xfrm>
                  <a:off x="7498314" y="3878646"/>
                  <a:ext cx="1097280" cy="26942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38,953    </a:t>
                  </a:r>
                </a:p>
              </p:txBody>
            </p:sp>
            <p:sp>
              <p:nvSpPr>
                <p:cNvPr id="84" name="Down Arrow 83"/>
                <p:cNvSpPr/>
                <p:nvPr/>
              </p:nvSpPr>
              <p:spPr>
                <a:xfrm>
                  <a:off x="4185840" y="3357945"/>
                  <a:ext cx="305259" cy="54864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85" name="Down Arrow 84"/>
                <p:cNvSpPr/>
                <p:nvPr/>
              </p:nvSpPr>
              <p:spPr>
                <a:xfrm>
                  <a:off x="7921944" y="3346901"/>
                  <a:ext cx="305259" cy="548640"/>
                </a:xfrm>
                <a:prstGeom prst="down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</p:grpSp>
          <p:sp>
            <p:nvSpPr>
              <p:cNvPr id="92" name="Rectangle 91"/>
              <p:cNvSpPr/>
              <p:nvPr/>
            </p:nvSpPr>
            <p:spPr>
              <a:xfrm>
                <a:off x="3472687" y="4515874"/>
                <a:ext cx="1188720" cy="269427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      91</a:t>
                </a:r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5249438" y="4535332"/>
                <a:ext cx="1097280" cy="269427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153</a:t>
                </a:r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9160374" y="4479254"/>
                <a:ext cx="1310150" cy="306493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59</a:t>
                </a:r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7283274" y="4516322"/>
                <a:ext cx="1097280" cy="269427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    111</a:t>
                </a:r>
              </a:p>
            </p:txBody>
          </p:sp>
          <p:sp>
            <p:nvSpPr>
              <p:cNvPr id="98" name="Down Arrow 97"/>
              <p:cNvSpPr/>
              <p:nvPr/>
            </p:nvSpPr>
            <p:spPr>
              <a:xfrm>
                <a:off x="3925279" y="4170591"/>
                <a:ext cx="305259" cy="365760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99" name="Down Arrow 98"/>
              <p:cNvSpPr/>
              <p:nvPr/>
            </p:nvSpPr>
            <p:spPr>
              <a:xfrm>
                <a:off x="7661382" y="4158234"/>
                <a:ext cx="305259" cy="365760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01" name="Down Arrow 100"/>
              <p:cNvSpPr/>
              <p:nvPr/>
            </p:nvSpPr>
            <p:spPr>
              <a:xfrm>
                <a:off x="5688993" y="4168344"/>
                <a:ext cx="305259" cy="365760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03" name="Down Arrow 102"/>
              <p:cNvSpPr/>
              <p:nvPr/>
            </p:nvSpPr>
            <p:spPr>
              <a:xfrm>
                <a:off x="9501956" y="4157800"/>
                <a:ext cx="289548" cy="329437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</p:grpSp>
        <p:sp>
          <p:nvSpPr>
            <p:cNvPr id="79" name="Rectangle 78"/>
            <p:cNvSpPr/>
            <p:nvPr/>
          </p:nvSpPr>
          <p:spPr>
            <a:xfrm>
              <a:off x="3798844" y="6266777"/>
              <a:ext cx="1188720" cy="273404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      52/</a:t>
              </a:r>
              <a:r>
                <a:rPr lang="en-US" dirty="0">
                  <a:solidFill>
                    <a:srgbClr val="FF0000"/>
                  </a:solidFill>
                </a:rPr>
                <a:t>39</a:t>
              </a: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5575595" y="6286523"/>
              <a:ext cx="1097280" cy="273404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55/</a:t>
              </a:r>
              <a:r>
                <a:rPr lang="en-US" dirty="0">
                  <a:solidFill>
                    <a:srgbClr val="FF0000"/>
                  </a:solidFill>
                </a:rPr>
                <a:t>98</a:t>
              </a: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9486530" y="6226980"/>
              <a:ext cx="1342705" cy="31365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42/</a:t>
              </a:r>
              <a:r>
                <a:rPr lang="en-US" dirty="0">
                  <a:solidFill>
                    <a:srgbClr val="FF0000"/>
                  </a:solidFill>
                </a:rPr>
                <a:t>17</a:t>
              </a: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7609431" y="6267232"/>
              <a:ext cx="1097280" cy="273404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55/</a:t>
              </a:r>
              <a:r>
                <a:rPr lang="en-US" dirty="0">
                  <a:solidFill>
                    <a:srgbClr val="FF0000"/>
                  </a:solidFill>
                </a:rPr>
                <a:t>56</a:t>
              </a:r>
            </a:p>
          </p:txBody>
        </p:sp>
        <p:sp>
          <p:nvSpPr>
            <p:cNvPr id="88" name="Down Arrow 87"/>
            <p:cNvSpPr/>
            <p:nvPr/>
          </p:nvSpPr>
          <p:spPr>
            <a:xfrm>
              <a:off x="4283990" y="5879562"/>
              <a:ext cx="305259" cy="371159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89" name="Down Arrow 88"/>
            <p:cNvSpPr/>
            <p:nvPr/>
          </p:nvSpPr>
          <p:spPr>
            <a:xfrm>
              <a:off x="8020093" y="5867023"/>
              <a:ext cx="305259" cy="371159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90" name="Down Arrow 89"/>
            <p:cNvSpPr/>
            <p:nvPr/>
          </p:nvSpPr>
          <p:spPr>
            <a:xfrm>
              <a:off x="6047704" y="5877282"/>
              <a:ext cx="305259" cy="371159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93" name="Down Arrow 92"/>
            <p:cNvSpPr/>
            <p:nvPr/>
          </p:nvSpPr>
          <p:spPr>
            <a:xfrm>
              <a:off x="9860666" y="5866581"/>
              <a:ext cx="305259" cy="371159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97" name="Rectangle 96"/>
            <p:cNvSpPr/>
            <p:nvPr/>
          </p:nvSpPr>
          <p:spPr>
            <a:xfrm>
              <a:off x="456654" y="5563765"/>
              <a:ext cx="3020316" cy="324389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lnSpc>
                  <a:spcPts val="1200"/>
                </a:lnSpc>
              </a:pPr>
              <a:r>
                <a:rPr lang="en-US" sz="1600" dirty="0"/>
                <a:t>miRNA prediction by </a:t>
              </a:r>
              <a:r>
                <a:rPr lang="en-US" sz="1600" dirty="0" err="1"/>
                <a:t>mirdeep</a:t>
              </a:r>
              <a:r>
                <a:rPr lang="en-US" sz="1600" dirty="0"/>
                <a:t>-P</a:t>
              </a:r>
            </a:p>
          </p:txBody>
        </p:sp>
        <p:sp>
          <p:nvSpPr>
            <p:cNvPr id="100" name="Down Arrow 99"/>
            <p:cNvSpPr/>
            <p:nvPr/>
          </p:nvSpPr>
          <p:spPr>
            <a:xfrm>
              <a:off x="1881877" y="5911332"/>
              <a:ext cx="305259" cy="371159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2187136" y="5927677"/>
              <a:ext cx="1038290" cy="29161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/>
                <a:t>Step 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4818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459</TotalTime>
  <Words>88</Words>
  <Application>Microsoft Macintosh PowerPoint</Application>
  <PresentationFormat>Custom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 Fuyou</dc:creator>
  <cp:lastModifiedBy>Gezahegn Girma</cp:lastModifiedBy>
  <cp:revision>140</cp:revision>
  <cp:lastPrinted>2018-05-18T13:07:49Z</cp:lastPrinted>
  <dcterms:created xsi:type="dcterms:W3CDTF">2016-03-16T14:37:35Z</dcterms:created>
  <dcterms:modified xsi:type="dcterms:W3CDTF">2020-06-10T00:18:38Z</dcterms:modified>
</cp:coreProperties>
</file>